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0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196" autoAdjust="0"/>
    <p:restoredTop sz="94660"/>
  </p:normalViewPr>
  <p:slideViewPr>
    <p:cSldViewPr snapToGrid="0">
      <p:cViewPr varScale="1">
        <p:scale>
          <a:sx n="76" d="100"/>
          <a:sy n="76" d="100"/>
        </p:scale>
        <p:origin x="314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chuster Gadi" userId="8014ead3-d102-41a2-8e53-d5bceadeebe2" providerId="ADAL" clId="{E7470423-E9D2-42EB-94C4-F83D031DF650}"/>
    <pc:docChg chg="custSel modSld">
      <pc:chgData name="Schuster Gadi" userId="8014ead3-d102-41a2-8e53-d5bceadeebe2" providerId="ADAL" clId="{E7470423-E9D2-42EB-94C4-F83D031DF650}" dt="2024-05-29T08:41:43.930" v="4" actId="1076"/>
      <pc:docMkLst>
        <pc:docMk/>
      </pc:docMkLst>
      <pc:sldChg chg="modSp mod">
        <pc:chgData name="Schuster Gadi" userId="8014ead3-d102-41a2-8e53-d5bceadeebe2" providerId="ADAL" clId="{E7470423-E9D2-42EB-94C4-F83D031DF650}" dt="2024-05-29T08:41:43.930" v="4" actId="1076"/>
        <pc:sldMkLst>
          <pc:docMk/>
          <pc:sldMk cId="2034325348" sldId="1341"/>
        </pc:sldMkLst>
        <pc:spChg chg="mod">
          <ac:chgData name="Schuster Gadi" userId="8014ead3-d102-41a2-8e53-d5bceadeebe2" providerId="ADAL" clId="{E7470423-E9D2-42EB-94C4-F83D031DF650}" dt="2024-05-29T08:41:43.930" v="4" actId="1076"/>
          <ac:spMkLst>
            <pc:docMk/>
            <pc:sldMk cId="2034325348" sldId="1341"/>
            <ac:spMk id="18" creationId="{351D47F2-9952-490B-8F22-8176E75E4E18}"/>
          </ac:spMkLst>
        </pc:spChg>
        <pc:spChg chg="mod">
          <ac:chgData name="Schuster Gadi" userId="8014ead3-d102-41a2-8e53-d5bceadeebe2" providerId="ADAL" clId="{E7470423-E9D2-42EB-94C4-F83D031DF650}" dt="2024-05-28T06:49:29.122" v="1" actId="313"/>
          <ac:spMkLst>
            <pc:docMk/>
            <pc:sldMk cId="2034325348" sldId="1341"/>
            <ac:spMk id="55" creationId="{18D0CA16-79D7-50D2-ACA1-12655DCE9869}"/>
          </ac:spMkLst>
        </pc:spChg>
        <pc:spChg chg="mod">
          <ac:chgData name="Schuster Gadi" userId="8014ead3-d102-41a2-8e53-d5bceadeebe2" providerId="ADAL" clId="{E7470423-E9D2-42EB-94C4-F83D031DF650}" dt="2024-05-28T06:49:33.174" v="3" actId="313"/>
          <ac:spMkLst>
            <pc:docMk/>
            <pc:sldMk cId="2034325348" sldId="1341"/>
            <ac:spMk id="61" creationId="{96332946-C41D-02AC-6D37-BE3997BC9C4A}"/>
          </ac:spMkLst>
        </pc:spChg>
      </pc:sldChg>
    </pc:docChg>
  </pc:docChgLst>
  <pc:docChgLst>
    <pc:chgData name="Guy Levin" userId="796a6ee1-938f-4754-82f4-44af232fdd3d" providerId="ADAL" clId="{71A9A29E-8629-4A1B-A2EC-F9D9E41292AC}"/>
    <pc:docChg chg="undo custSel modSld">
      <pc:chgData name="Guy Levin" userId="796a6ee1-938f-4754-82f4-44af232fdd3d" providerId="ADAL" clId="{71A9A29E-8629-4A1B-A2EC-F9D9E41292AC}" dt="2024-08-27T19:13:45.463" v="16" actId="20577"/>
      <pc:docMkLst>
        <pc:docMk/>
      </pc:docMkLst>
      <pc:sldChg chg="addSp delSp modSp">
        <pc:chgData name="Guy Levin" userId="796a6ee1-938f-4754-82f4-44af232fdd3d" providerId="ADAL" clId="{71A9A29E-8629-4A1B-A2EC-F9D9E41292AC}" dt="2024-08-26T09:09:15.358" v="14" actId="1076"/>
        <pc:sldMkLst>
          <pc:docMk/>
          <pc:sldMk cId="4102523903" sldId="290"/>
        </pc:sldMkLst>
        <pc:spChg chg="del">
          <ac:chgData name="Guy Levin" userId="796a6ee1-938f-4754-82f4-44af232fdd3d" providerId="ADAL" clId="{71A9A29E-8629-4A1B-A2EC-F9D9E41292AC}" dt="2024-08-26T09:08:59.611" v="12" actId="478"/>
          <ac:spMkLst>
            <pc:docMk/>
            <pc:sldMk cId="4102523903" sldId="290"/>
            <ac:spMk id="21" creationId="{058936D1-6581-426F-8746-9048BC216317}"/>
          </ac:spMkLst>
        </pc:spChg>
        <pc:spChg chg="add mod">
          <ac:chgData name="Guy Levin" userId="796a6ee1-938f-4754-82f4-44af232fdd3d" providerId="ADAL" clId="{71A9A29E-8629-4A1B-A2EC-F9D9E41292AC}" dt="2024-08-26T09:09:15.358" v="14" actId="1076"/>
          <ac:spMkLst>
            <pc:docMk/>
            <pc:sldMk cId="4102523903" sldId="290"/>
            <ac:spMk id="28" creationId="{058936D1-6581-426F-8746-9048BC216317}"/>
          </ac:spMkLst>
        </pc:spChg>
      </pc:sldChg>
      <pc:sldChg chg="addSp delSp modSp">
        <pc:chgData name="Guy Levin" userId="796a6ee1-938f-4754-82f4-44af232fdd3d" providerId="ADAL" clId="{71A9A29E-8629-4A1B-A2EC-F9D9E41292AC}" dt="2024-08-26T09:08:43.047" v="8" actId="1076"/>
        <pc:sldMkLst>
          <pc:docMk/>
          <pc:sldMk cId="1432036717" sldId="299"/>
        </pc:sldMkLst>
        <pc:spChg chg="del">
          <ac:chgData name="Guy Levin" userId="796a6ee1-938f-4754-82f4-44af232fdd3d" providerId="ADAL" clId="{71A9A29E-8629-4A1B-A2EC-F9D9E41292AC}" dt="2024-08-26T09:08:27.524" v="4" actId="478"/>
          <ac:spMkLst>
            <pc:docMk/>
            <pc:sldMk cId="1432036717" sldId="299"/>
            <ac:spMk id="3" creationId="{FAEEBF45-B1CE-41D6-8ED1-AE1699FC69DD}"/>
          </ac:spMkLst>
        </pc:spChg>
        <pc:spChg chg="add mod">
          <ac:chgData name="Guy Levin" userId="796a6ee1-938f-4754-82f4-44af232fdd3d" providerId="ADAL" clId="{71A9A29E-8629-4A1B-A2EC-F9D9E41292AC}" dt="2024-08-26T09:08:43.047" v="8" actId="1076"/>
          <ac:spMkLst>
            <pc:docMk/>
            <pc:sldMk cId="1432036717" sldId="299"/>
            <ac:spMk id="26" creationId="{C11AA62B-374B-4F49-ADFB-BCD75BCA9C29}"/>
          </ac:spMkLst>
        </pc:spChg>
        <pc:picChg chg="mod">
          <ac:chgData name="Guy Levin" userId="796a6ee1-938f-4754-82f4-44af232fdd3d" providerId="ADAL" clId="{71A9A29E-8629-4A1B-A2EC-F9D9E41292AC}" dt="2024-08-26T09:08:39.428" v="7" actId="1076"/>
          <ac:picMkLst>
            <pc:docMk/>
            <pc:sldMk cId="1432036717" sldId="299"/>
            <ac:picMk id="4" creationId="{FFC30E95-BD35-4623-996C-6B14A747A8C0}"/>
          </ac:picMkLst>
        </pc:picChg>
      </pc:sldChg>
      <pc:sldChg chg="addSp delSp modSp">
        <pc:chgData name="Guy Levin" userId="796a6ee1-938f-4754-82f4-44af232fdd3d" providerId="ADAL" clId="{71A9A29E-8629-4A1B-A2EC-F9D9E41292AC}" dt="2024-08-26T09:08:56.534" v="11" actId="1076"/>
        <pc:sldMkLst>
          <pc:docMk/>
          <pc:sldMk cId="2828842376" sldId="305"/>
        </pc:sldMkLst>
        <pc:spChg chg="del">
          <ac:chgData name="Guy Levin" userId="796a6ee1-938f-4754-82f4-44af232fdd3d" providerId="ADAL" clId="{71A9A29E-8629-4A1B-A2EC-F9D9E41292AC}" dt="2024-08-26T09:08:49.131" v="9" actId="478"/>
          <ac:spMkLst>
            <pc:docMk/>
            <pc:sldMk cId="2828842376" sldId="305"/>
            <ac:spMk id="42" creationId="{5D37DAEB-9531-4C3F-AB3B-0D625453EAAA}"/>
          </ac:spMkLst>
        </pc:spChg>
        <pc:spChg chg="add mod">
          <ac:chgData name="Guy Levin" userId="796a6ee1-938f-4754-82f4-44af232fdd3d" providerId="ADAL" clId="{71A9A29E-8629-4A1B-A2EC-F9D9E41292AC}" dt="2024-08-26T09:08:56.534" v="11" actId="1076"/>
          <ac:spMkLst>
            <pc:docMk/>
            <pc:sldMk cId="2828842376" sldId="305"/>
            <ac:spMk id="46" creationId="{5D37DAEB-9531-4C3F-AB3B-0D625453EAAA}"/>
          </ac:spMkLst>
        </pc:spChg>
      </pc:sldChg>
      <pc:sldChg chg="addSp delSp modSp">
        <pc:chgData name="Guy Levin" userId="796a6ee1-938f-4754-82f4-44af232fdd3d" providerId="ADAL" clId="{71A9A29E-8629-4A1B-A2EC-F9D9E41292AC}" dt="2024-08-27T19:13:45.463" v="16" actId="20577"/>
        <pc:sldMkLst>
          <pc:docMk/>
          <pc:sldMk cId="2034325348" sldId="1341"/>
        </pc:sldMkLst>
        <pc:spChg chg="del">
          <ac:chgData name="Guy Levin" userId="796a6ee1-938f-4754-82f4-44af232fdd3d" providerId="ADAL" clId="{71A9A29E-8629-4A1B-A2EC-F9D9E41292AC}" dt="2024-08-26T09:08:20.284" v="2" actId="478"/>
          <ac:spMkLst>
            <pc:docMk/>
            <pc:sldMk cId="2034325348" sldId="1341"/>
            <ac:spMk id="18" creationId="{351D47F2-9952-490B-8F22-8176E75E4E18}"/>
          </ac:spMkLst>
        </pc:spChg>
        <pc:spChg chg="add mod">
          <ac:chgData name="Guy Levin" userId="796a6ee1-938f-4754-82f4-44af232fdd3d" providerId="ADAL" clId="{71A9A29E-8629-4A1B-A2EC-F9D9E41292AC}" dt="2024-08-26T09:08:23.286" v="3" actId="1076"/>
          <ac:spMkLst>
            <pc:docMk/>
            <pc:sldMk cId="2034325348" sldId="1341"/>
            <ac:spMk id="31" creationId="{351D47F2-9952-490B-8F22-8176E75E4E18}"/>
          </ac:spMkLst>
        </pc:spChg>
        <pc:spChg chg="mod">
          <ac:chgData name="Guy Levin" userId="796a6ee1-938f-4754-82f4-44af232fdd3d" providerId="ADAL" clId="{71A9A29E-8629-4A1B-A2EC-F9D9E41292AC}" dt="2024-08-27T19:13:45.463" v="16" actId="20577"/>
          <ac:spMkLst>
            <pc:docMk/>
            <pc:sldMk cId="2034325348" sldId="1341"/>
            <ac:spMk id="32" creationId="{4E08334C-5551-4F10-B8D2-414AF554C9CF}"/>
          </ac:spMkLst>
        </pc:spChg>
        <pc:spChg chg="mod">
          <ac:chgData name="Guy Levin" userId="796a6ee1-938f-4754-82f4-44af232fdd3d" providerId="ADAL" clId="{71A9A29E-8629-4A1B-A2EC-F9D9E41292AC}" dt="2024-08-27T19:13:42.712" v="15" actId="20577"/>
          <ac:spMkLst>
            <pc:docMk/>
            <pc:sldMk cId="2034325348" sldId="1341"/>
            <ac:spMk id="39" creationId="{442F91BD-7E58-4516-A0E5-B1741BB1CD70}"/>
          </ac:spMkLst>
        </pc:spChg>
      </pc:sldChg>
    </pc:docChg>
  </pc:docChgLst>
  <pc:docChgLst>
    <pc:chgData name="Guy Levin" userId="796a6ee1-938f-4754-82f4-44af232fdd3d" providerId="ADAL" clId="{65675048-CCC5-4663-A5ED-1EE0BAA0D74C}"/>
    <pc:docChg chg="undo custSel modSld">
      <pc:chgData name="Guy Levin" userId="796a6ee1-938f-4754-82f4-44af232fdd3d" providerId="ADAL" clId="{65675048-CCC5-4663-A5ED-1EE0BAA0D74C}" dt="2024-06-10T12:25:06.540" v="24" actId="478"/>
      <pc:docMkLst>
        <pc:docMk/>
      </pc:docMkLst>
      <pc:sldChg chg="delSp modSp">
        <pc:chgData name="Guy Levin" userId="796a6ee1-938f-4754-82f4-44af232fdd3d" providerId="ADAL" clId="{65675048-CCC5-4663-A5ED-1EE0BAA0D74C}" dt="2024-06-10T12:25:06.540" v="24" actId="478"/>
        <pc:sldMkLst>
          <pc:docMk/>
          <pc:sldMk cId="1432036717" sldId="299"/>
        </pc:sldMkLst>
        <pc:spChg chg="mod">
          <ac:chgData name="Guy Levin" userId="796a6ee1-938f-4754-82f4-44af232fdd3d" providerId="ADAL" clId="{65675048-CCC5-4663-A5ED-1EE0BAA0D74C}" dt="2024-06-10T12:24:12.117" v="23" actId="20577"/>
          <ac:spMkLst>
            <pc:docMk/>
            <pc:sldMk cId="1432036717" sldId="299"/>
            <ac:spMk id="3" creationId="{FAEEBF45-B1CE-41D6-8ED1-AE1699FC69DD}"/>
          </ac:spMkLst>
        </pc:spChg>
        <pc:spChg chg="del">
          <ac:chgData name="Guy Levin" userId="796a6ee1-938f-4754-82f4-44af232fdd3d" providerId="ADAL" clId="{65675048-CCC5-4663-A5ED-1EE0BAA0D74C}" dt="2024-06-10T12:25:06.540" v="24" actId="478"/>
          <ac:spMkLst>
            <pc:docMk/>
            <pc:sldMk cId="1432036717" sldId="299"/>
            <ac:spMk id="26" creationId="{2F0EF0D1-ABFB-119A-65D4-C9554E040AEE}"/>
          </ac:spMkLst>
        </pc:spChg>
      </pc:sldChg>
      <pc:sldChg chg="addSp delSp modSp">
        <pc:chgData name="Guy Levin" userId="796a6ee1-938f-4754-82f4-44af232fdd3d" providerId="ADAL" clId="{65675048-CCC5-4663-A5ED-1EE0BAA0D74C}" dt="2024-06-10T12:21:54.669" v="17" actId="1076"/>
        <pc:sldMkLst>
          <pc:docMk/>
          <pc:sldMk cId="2034325348" sldId="1341"/>
        </pc:sldMkLst>
        <pc:spChg chg="del">
          <ac:chgData name="Guy Levin" userId="796a6ee1-938f-4754-82f4-44af232fdd3d" providerId="ADAL" clId="{65675048-CCC5-4663-A5ED-1EE0BAA0D74C}" dt="2024-05-28T08:25:06.213" v="5" actId="478"/>
          <ac:spMkLst>
            <pc:docMk/>
            <pc:sldMk cId="2034325348" sldId="1341"/>
            <ac:spMk id="2" creationId="{55E46FE8-192C-4312-9422-40CB7E225B57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3" creationId="{165C13E4-BA30-EEEC-9915-48143670ED7A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6" creationId="{33CB28F7-7461-3EF5-B9B7-3105B0B2206D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7" creationId="{CC2CA53A-FD0B-4E93-A8B1-720ED9487CEF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8" creationId="{71718261-F870-405A-818B-40CA1C0E0621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9" creationId="{F53BD0DB-512E-45F4-BB54-B16EAC518175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10" creationId="{92998ABC-1CA5-4925-B230-FA541E090F4D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11" creationId="{A87B4BDE-161F-4D79-9B7F-E6C5015FE53C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12" creationId="{AF079CAE-64DD-20D7-62FC-A8309E8F4D39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13" creationId="{7DE3C3B9-D187-A150-9245-94703824B1DD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14" creationId="{45215AE7-9B66-D777-8C8C-7FBC30B43652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18" creationId="{351D47F2-9952-490B-8F22-8176E75E4E18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19" creationId="{3EAF3056-30CA-4278-A4D3-F03EBD4B6945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27" creationId="{CFBCC9AD-A44C-4320-A224-5A980C2F45AE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32" creationId="{4E08334C-5551-4F10-B8D2-414AF554C9CF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39" creationId="{442F91BD-7E58-4516-A0E5-B1741BB1CD70}"/>
          </ac:spMkLst>
        </pc:spChg>
        <pc:spChg chg="add del mod">
          <ac:chgData name="Guy Levin" userId="796a6ee1-938f-4754-82f4-44af232fdd3d" providerId="ADAL" clId="{65675048-CCC5-4663-A5ED-1EE0BAA0D74C}" dt="2024-06-10T12:21:45.788" v="16" actId="478"/>
          <ac:spMkLst>
            <pc:docMk/>
            <pc:sldMk cId="2034325348" sldId="1341"/>
            <ac:spMk id="42" creationId="{F54F0CF5-7E95-9CF3-D830-D6C8FE1DDA12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43" creationId="{C48E2339-A1DD-771A-80C7-9940FC2FABB5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44" creationId="{90CF2406-3037-9C9C-AF1E-DE7FA3E90D61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45" creationId="{D36347BB-CBDC-25D6-7DF2-50711EC7F98E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46" creationId="{08DD1927-D977-D767-A09F-140F79C784B0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47" creationId="{CF8A812E-FB7B-D64B-A87E-71041EBFC7E8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48" creationId="{DA840B66-9B47-8EA6-9183-B6D11B2648B3}"/>
          </ac:spMkLst>
        </pc:spChg>
        <pc:spChg chg="del">
          <ac:chgData name="Guy Levin" userId="796a6ee1-938f-4754-82f4-44af232fdd3d" providerId="ADAL" clId="{65675048-CCC5-4663-A5ED-1EE0BAA0D74C}" dt="2024-05-28T08:24:56.670" v="3" actId="478"/>
          <ac:spMkLst>
            <pc:docMk/>
            <pc:sldMk cId="2034325348" sldId="1341"/>
            <ac:spMk id="49" creationId="{E7741978-D8C9-2318-5BF5-1DBF5E6B8D0A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50" creationId="{61E5856D-B67D-8DE6-EBDC-E066CE75D44B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51" creationId="{AB10EBB5-A46F-7696-9F1A-887F9817DBA5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52" creationId="{56642583-FDEC-457F-5062-C68A665985C6}"/>
          </ac:spMkLst>
        </pc:spChg>
        <pc:spChg chg="del">
          <ac:chgData name="Guy Levin" userId="796a6ee1-938f-4754-82f4-44af232fdd3d" providerId="ADAL" clId="{65675048-CCC5-4663-A5ED-1EE0BAA0D74C}" dt="2024-05-28T08:25:02.940" v="4" actId="478"/>
          <ac:spMkLst>
            <pc:docMk/>
            <pc:sldMk cId="2034325348" sldId="1341"/>
            <ac:spMk id="53" creationId="{3C8F68FA-E444-0ECD-0207-B9E3B00412A4}"/>
          </ac:spMkLst>
        </pc:spChg>
        <pc:spChg chg="del">
          <ac:chgData name="Guy Levin" userId="796a6ee1-938f-4754-82f4-44af232fdd3d" providerId="ADAL" clId="{65675048-CCC5-4663-A5ED-1EE0BAA0D74C}" dt="2024-05-28T08:24:56.670" v="3" actId="478"/>
          <ac:spMkLst>
            <pc:docMk/>
            <pc:sldMk cId="2034325348" sldId="1341"/>
            <ac:spMk id="54" creationId="{2286ECCD-B173-3DFA-4B20-67505863486A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55" creationId="{18D0CA16-79D7-50D2-ACA1-12655DCE9869}"/>
          </ac:spMkLst>
        </pc:spChg>
        <pc:spChg chg="mod">
          <ac:chgData name="Guy Levin" userId="796a6ee1-938f-4754-82f4-44af232fdd3d" providerId="ADAL" clId="{65675048-CCC5-4663-A5ED-1EE0BAA0D74C}" dt="2024-06-10T12:21:54.669" v="17" actId="1076"/>
          <ac:spMkLst>
            <pc:docMk/>
            <pc:sldMk cId="2034325348" sldId="1341"/>
            <ac:spMk id="61" creationId="{96332946-C41D-02AC-6D37-BE3997BC9C4A}"/>
          </ac:spMkLst>
        </pc:spChg>
        <pc:spChg chg="del">
          <ac:chgData name="Guy Levin" userId="796a6ee1-938f-4754-82f4-44af232fdd3d" providerId="ADAL" clId="{65675048-CCC5-4663-A5ED-1EE0BAA0D74C}" dt="2024-05-28T08:25:09.671" v="6" actId="478"/>
          <ac:spMkLst>
            <pc:docMk/>
            <pc:sldMk cId="2034325348" sldId="1341"/>
            <ac:spMk id="65" creationId="{18CA557C-D93A-5EE2-A05D-7D7565907F58}"/>
          </ac:spMkLst>
        </pc:spChg>
        <pc:grpChg chg="del">
          <ac:chgData name="Guy Levin" userId="796a6ee1-938f-4754-82f4-44af232fdd3d" providerId="ADAL" clId="{65675048-CCC5-4663-A5ED-1EE0BAA0D74C}" dt="2024-05-28T08:25:02.940" v="4" actId="478"/>
          <ac:grpSpMkLst>
            <pc:docMk/>
            <pc:sldMk cId="2034325348" sldId="1341"/>
            <ac:grpSpMk id="29" creationId="{CC4D41E3-3319-4983-A208-66D0FC1AB5AB}"/>
          </ac:grpSpMkLst>
        </pc:grpChg>
        <pc:graphicFrameChg chg="mod">
          <ac:chgData name="Guy Levin" userId="796a6ee1-938f-4754-82f4-44af232fdd3d" providerId="ADAL" clId="{65675048-CCC5-4663-A5ED-1EE0BAA0D74C}" dt="2024-06-10T12:21:54.669" v="17" actId="1076"/>
          <ac:graphicFrameMkLst>
            <pc:docMk/>
            <pc:sldMk cId="2034325348" sldId="1341"/>
            <ac:graphicFrameMk id="24" creationId="{7A4B8413-4EA1-419B-B015-CE81E9A436DF}"/>
          </ac:graphicFrameMkLst>
        </pc:graphicFrameChg>
        <pc:graphicFrameChg chg="mod">
          <ac:chgData name="Guy Levin" userId="796a6ee1-938f-4754-82f4-44af232fdd3d" providerId="ADAL" clId="{65675048-CCC5-4663-A5ED-1EE0BAA0D74C}" dt="2024-06-10T12:21:54.669" v="17" actId="1076"/>
          <ac:graphicFrameMkLst>
            <pc:docMk/>
            <pc:sldMk cId="2034325348" sldId="1341"/>
            <ac:graphicFrameMk id="25" creationId="{D527C7FC-D266-464D-AC00-9E823F3D3132}"/>
          </ac:graphicFrameMkLst>
        </pc:graphicFrameChg>
        <pc:graphicFrameChg chg="del mod">
          <ac:chgData name="Guy Levin" userId="796a6ee1-938f-4754-82f4-44af232fdd3d" providerId="ADAL" clId="{65675048-CCC5-4663-A5ED-1EE0BAA0D74C}" dt="2024-05-28T08:25:02.940" v="4" actId="478"/>
          <ac:graphicFrameMkLst>
            <pc:docMk/>
            <pc:sldMk cId="2034325348" sldId="1341"/>
            <ac:graphicFrameMk id="26" creationId="{EDFB0453-9FA4-4A12-AAC9-712B52B6094D}"/>
          </ac:graphicFrameMkLst>
        </pc:graphicFrameChg>
        <pc:graphicFrameChg chg="del">
          <ac:chgData name="Guy Levin" userId="796a6ee1-938f-4754-82f4-44af232fdd3d" providerId="ADAL" clId="{65675048-CCC5-4663-A5ED-1EE0BAA0D74C}" dt="2024-05-28T08:24:54.321" v="2" actId="478"/>
          <ac:graphicFrameMkLst>
            <pc:docMk/>
            <pc:sldMk cId="2034325348" sldId="1341"/>
            <ac:graphicFrameMk id="33" creationId="{FC92DF1C-A388-4E18-A40A-24379A5F7132}"/>
          </ac:graphicFrameMkLst>
        </pc:graphicFrameChg>
        <pc:graphicFrameChg chg="add del mod">
          <ac:chgData name="Guy Levin" userId="796a6ee1-938f-4754-82f4-44af232fdd3d" providerId="ADAL" clId="{65675048-CCC5-4663-A5ED-1EE0BAA0D74C}" dt="2024-06-10T12:21:41.736" v="14" actId="478"/>
          <ac:graphicFrameMkLst>
            <pc:docMk/>
            <pc:sldMk cId="2034325348" sldId="1341"/>
            <ac:graphicFrameMk id="56" creationId="{D15D6FC2-6851-4B2E-847B-99E6A4252B51}"/>
          </ac:graphicFrameMkLst>
        </pc:graphicFrameChg>
        <pc:picChg chg="mod">
          <ac:chgData name="Guy Levin" userId="796a6ee1-938f-4754-82f4-44af232fdd3d" providerId="ADAL" clId="{65675048-CCC5-4663-A5ED-1EE0BAA0D74C}" dt="2024-06-10T12:21:54.669" v="17" actId="1076"/>
          <ac:picMkLst>
            <pc:docMk/>
            <pc:sldMk cId="2034325348" sldId="1341"/>
            <ac:picMk id="4" creationId="{35AB84AC-F5FF-40C7-A759-6AC20D7BDB50}"/>
          </ac:picMkLst>
        </pc:picChg>
        <pc:picChg chg="mod">
          <ac:chgData name="Guy Levin" userId="796a6ee1-938f-4754-82f4-44af232fdd3d" providerId="ADAL" clId="{65675048-CCC5-4663-A5ED-1EE0BAA0D74C}" dt="2024-06-10T12:21:54.669" v="17" actId="1076"/>
          <ac:picMkLst>
            <pc:docMk/>
            <pc:sldMk cId="2034325348" sldId="1341"/>
            <ac:picMk id="5" creationId="{A278E044-1B9A-473A-83C4-1E829CFFA60F}"/>
          </ac:picMkLst>
        </pc:picChg>
        <pc:cxnChg chg="mod">
          <ac:chgData name="Guy Levin" userId="796a6ee1-938f-4754-82f4-44af232fdd3d" providerId="ADAL" clId="{65675048-CCC5-4663-A5ED-1EE0BAA0D74C}" dt="2024-06-10T12:21:54.669" v="17" actId="1076"/>
          <ac:cxnSpMkLst>
            <pc:docMk/>
            <pc:sldMk cId="2034325348" sldId="1341"/>
            <ac:cxnSpMk id="57" creationId="{928D54EA-EE16-194A-C19F-74BE30C7F4FC}"/>
          </ac:cxnSpMkLst>
        </pc:cxnChg>
        <pc:cxnChg chg="mod">
          <ac:chgData name="Guy Levin" userId="796a6ee1-938f-4754-82f4-44af232fdd3d" providerId="ADAL" clId="{65675048-CCC5-4663-A5ED-1EE0BAA0D74C}" dt="2024-06-10T12:21:54.669" v="17" actId="1076"/>
          <ac:cxnSpMkLst>
            <pc:docMk/>
            <pc:sldMk cId="2034325348" sldId="1341"/>
            <ac:cxnSpMk id="59" creationId="{5EB2AD94-AF6F-C711-1083-456F64ED4610}"/>
          </ac:cxnSpMkLst>
        </pc:cxnChg>
        <pc:cxnChg chg="mod">
          <ac:chgData name="Guy Levin" userId="796a6ee1-938f-4754-82f4-44af232fdd3d" providerId="ADAL" clId="{65675048-CCC5-4663-A5ED-1EE0BAA0D74C}" dt="2024-06-10T12:21:54.669" v="17" actId="1076"/>
          <ac:cxnSpMkLst>
            <pc:docMk/>
            <pc:sldMk cId="2034325348" sldId="1341"/>
            <ac:cxnSpMk id="60" creationId="{BB9922AD-D9C8-62A2-B090-E7A09F1482A3}"/>
          </ac:cxnSpMkLst>
        </pc:cxnChg>
        <pc:cxnChg chg="mod">
          <ac:chgData name="Guy Levin" userId="796a6ee1-938f-4754-82f4-44af232fdd3d" providerId="ADAL" clId="{65675048-CCC5-4663-A5ED-1EE0BAA0D74C}" dt="2024-06-10T12:21:54.669" v="17" actId="1076"/>
          <ac:cxnSpMkLst>
            <pc:docMk/>
            <pc:sldMk cId="2034325348" sldId="1341"/>
            <ac:cxnSpMk id="62" creationId="{808387B6-212A-3E56-0137-87339CE337FB}"/>
          </ac:cxnSpMkLst>
        </pc:cxnChg>
        <pc:cxnChg chg="mod">
          <ac:chgData name="Guy Levin" userId="796a6ee1-938f-4754-82f4-44af232fdd3d" providerId="ADAL" clId="{65675048-CCC5-4663-A5ED-1EE0BAA0D74C}" dt="2024-06-10T12:21:54.669" v="17" actId="1076"/>
          <ac:cxnSpMkLst>
            <pc:docMk/>
            <pc:sldMk cId="2034325348" sldId="1341"/>
            <ac:cxnSpMk id="63" creationId="{871009F6-5DD7-242F-8F13-7C84975816DC}"/>
          </ac:cxnSpMkLst>
        </pc:cxnChg>
        <pc:cxnChg chg="mod">
          <ac:chgData name="Guy Levin" userId="796a6ee1-938f-4754-82f4-44af232fdd3d" providerId="ADAL" clId="{65675048-CCC5-4663-A5ED-1EE0BAA0D74C}" dt="2024-06-10T12:21:54.669" v="17" actId="1076"/>
          <ac:cxnSpMkLst>
            <pc:docMk/>
            <pc:sldMk cId="2034325348" sldId="1341"/>
            <ac:cxnSpMk id="64" creationId="{CB172AF9-73CE-263C-FBEC-C06E401178A2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709135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123372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151846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312786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620784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1643413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5855481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25507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5995239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891811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155418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B8E186-0FD4-4CC8-B64F-C6AA0C61C1E7}" type="datetimeFigureOut">
              <a:rPr lang="en-IL" smtClean="0"/>
              <a:t>19/09/2024</a:t>
            </a:fld>
            <a:endParaRPr lang="en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4C7315-B3D0-4FA9-A887-5262B5CB6B01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6282099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Group 46">
            <a:extLst>
              <a:ext uri="{FF2B5EF4-FFF2-40B4-BE49-F238E27FC236}">
                <a16:creationId xmlns:a16="http://schemas.microsoft.com/office/drawing/2014/main" id="{BFD8E142-8A61-4748-AB48-C2711972F62B}"/>
              </a:ext>
            </a:extLst>
          </p:cNvPr>
          <p:cNvGrpSpPr/>
          <p:nvPr/>
        </p:nvGrpSpPr>
        <p:grpSpPr>
          <a:xfrm>
            <a:off x="48414" y="420017"/>
            <a:ext cx="3343092" cy="2122634"/>
            <a:chOff x="6942221" y="4485234"/>
            <a:chExt cx="4698573" cy="2521008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53105414-8774-40EE-ACAB-234D6A70E3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050" t="14000" r="22000" b="23600"/>
            <a:stretch/>
          </p:blipFill>
          <p:spPr>
            <a:xfrm>
              <a:off x="6942221" y="4863032"/>
              <a:ext cx="4698573" cy="2143210"/>
            </a:xfrm>
            <a:prstGeom prst="rect">
              <a:avLst/>
            </a:prstGeom>
          </p:spPr>
        </p:pic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F930C778-B3EA-4D19-A8B4-FCAF21DC628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467775" y="6479031"/>
              <a:ext cx="72414" cy="15904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AC432B9-FA73-4A8A-954C-9BC1F8C03B7E}"/>
                </a:ext>
              </a:extLst>
            </p:cNvPr>
            <p:cNvSpPr txBox="1"/>
            <p:nvPr/>
          </p:nvSpPr>
          <p:spPr>
            <a:xfrm>
              <a:off x="10340702" y="6224271"/>
              <a:ext cx="928997" cy="3655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/>
                <a:t>Acid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B7FE25B-4666-4886-B0FA-9A716EAA1280}"/>
                </a:ext>
              </a:extLst>
            </p:cNvPr>
            <p:cNvSpPr txBox="1"/>
            <p:nvPr/>
          </p:nvSpPr>
          <p:spPr>
            <a:xfrm>
              <a:off x="9209138" y="4485234"/>
              <a:ext cx="534400" cy="4386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rgbClr val="0070C0"/>
                  </a:solidFill>
                </a:rPr>
                <a:t>LL</a:t>
              </a: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5E60E16F-9B7D-4237-B90F-407EBB58F595}"/>
                </a:ext>
              </a:extLst>
            </p:cNvPr>
            <p:cNvSpPr/>
            <p:nvPr/>
          </p:nvSpPr>
          <p:spPr>
            <a:xfrm>
              <a:off x="7153911" y="4571680"/>
              <a:ext cx="992263" cy="47520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/>
                <a:t>NPQ</a:t>
              </a:r>
            </a:p>
            <a:p>
              <a:pPr algn="ctr"/>
              <a:r>
                <a:rPr lang="en-US" sz="1000" b="1"/>
                <a:t> </a:t>
              </a:r>
              <a:r>
                <a:rPr lang="en-IL" sz="700"/>
                <a:t>0.0</a:t>
              </a:r>
              <a:r>
                <a:rPr lang="en-US" sz="700"/>
                <a:t>61</a:t>
              </a: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75B67048-98F5-4ABF-A13D-47317C502934}"/>
                </a:ext>
              </a:extLst>
            </p:cNvPr>
            <p:cNvSpPr/>
            <p:nvPr/>
          </p:nvSpPr>
          <p:spPr>
            <a:xfrm>
              <a:off x="7590294" y="5054572"/>
              <a:ext cx="666694" cy="23760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IL" sz="700"/>
                <a:t>0.1</a:t>
              </a:r>
              <a:r>
                <a:rPr lang="en-US" sz="700"/>
                <a:t>44</a:t>
              </a:r>
              <a:endParaRPr lang="en-IL" sz="700"/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9D07BD50-801A-483C-B636-93E327F9F8C8}"/>
                </a:ext>
              </a:extLst>
            </p:cNvPr>
            <p:cNvSpPr/>
            <p:nvPr/>
          </p:nvSpPr>
          <p:spPr>
            <a:xfrm>
              <a:off x="7878572" y="5118793"/>
              <a:ext cx="666694" cy="23760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IL" sz="700">
                  <a:solidFill>
                    <a:prstClr val="black"/>
                  </a:solidFill>
                </a:rPr>
                <a:t>0.1</a:t>
              </a:r>
              <a:r>
                <a:rPr lang="en-US" sz="700">
                  <a:solidFill>
                    <a:prstClr val="black"/>
                  </a:solidFill>
                </a:rPr>
                <a:t>66</a:t>
              </a:r>
              <a:endParaRPr lang="en-IL" sz="700">
                <a:solidFill>
                  <a:prstClr val="black"/>
                </a:solidFill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2A5FF68B-B3EF-4E05-A8F5-BC772E6CF5B7}"/>
                </a:ext>
              </a:extLst>
            </p:cNvPr>
            <p:cNvSpPr/>
            <p:nvPr/>
          </p:nvSpPr>
          <p:spPr>
            <a:xfrm>
              <a:off x="8088369" y="5014728"/>
              <a:ext cx="666694" cy="23760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IL" sz="700">
                  <a:solidFill>
                    <a:prstClr val="black"/>
                  </a:solidFill>
                </a:rPr>
                <a:t>0.</a:t>
              </a:r>
              <a:r>
                <a:rPr lang="en-US" sz="700">
                  <a:solidFill>
                    <a:prstClr val="black"/>
                  </a:solidFill>
                </a:rPr>
                <a:t>198</a:t>
              </a:r>
              <a:endParaRPr lang="en-IL" sz="700">
                <a:solidFill>
                  <a:prstClr val="black"/>
                </a:solidFill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B61488AF-2D79-47F7-8AFB-A7D93DB75816}"/>
                </a:ext>
              </a:extLst>
            </p:cNvPr>
            <p:cNvSpPr/>
            <p:nvPr/>
          </p:nvSpPr>
          <p:spPr>
            <a:xfrm>
              <a:off x="8261189" y="5183854"/>
              <a:ext cx="666694" cy="23760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IL" sz="700">
                  <a:solidFill>
                    <a:prstClr val="black"/>
                  </a:solidFill>
                </a:rPr>
                <a:t>0.</a:t>
              </a:r>
              <a:r>
                <a:rPr lang="en-US" sz="700">
                  <a:solidFill>
                    <a:prstClr val="black"/>
                  </a:solidFill>
                </a:rPr>
                <a:t>186</a:t>
              </a:r>
              <a:endParaRPr lang="en-IL" sz="700">
                <a:solidFill>
                  <a:prstClr val="black"/>
                </a:solidFill>
              </a:endParaRPr>
            </a:p>
          </p:txBody>
        </p: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3AAD18B2-9B6B-4724-99BF-0CCFE865F50E}"/>
                </a:ext>
              </a:extLst>
            </p:cNvPr>
            <p:cNvCxnSpPr>
              <a:cxnSpLocks/>
            </p:cNvCxnSpPr>
            <p:nvPr/>
          </p:nvCxnSpPr>
          <p:spPr>
            <a:xfrm>
              <a:off x="7466022" y="6479031"/>
              <a:ext cx="147084" cy="30860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3B89174F-73BC-43A0-8086-A9B47FFD3437}"/>
                </a:ext>
              </a:extLst>
            </p:cNvPr>
            <p:cNvSpPr/>
            <p:nvPr/>
          </p:nvSpPr>
          <p:spPr>
            <a:xfrm>
              <a:off x="8570670" y="5143522"/>
              <a:ext cx="666694" cy="23760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IL" sz="700">
                  <a:solidFill>
                    <a:prstClr val="black"/>
                  </a:solidFill>
                </a:rPr>
                <a:t>0.</a:t>
              </a:r>
              <a:r>
                <a:rPr lang="en-US" sz="700">
                  <a:solidFill>
                    <a:prstClr val="black"/>
                  </a:solidFill>
                </a:rPr>
                <a:t>172</a:t>
              </a:r>
              <a:endParaRPr lang="en-IL" sz="700">
                <a:solidFill>
                  <a:prstClr val="black"/>
                </a:solidFill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A832292C-2789-4F58-9E5B-67340DA27E76}"/>
                </a:ext>
              </a:extLst>
            </p:cNvPr>
            <p:cNvSpPr/>
            <p:nvPr/>
          </p:nvSpPr>
          <p:spPr>
            <a:xfrm>
              <a:off x="8888729" y="5113362"/>
              <a:ext cx="666694" cy="23760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sz="700">
                  <a:solidFill>
                    <a:prstClr val="black"/>
                  </a:solidFill>
                </a:rPr>
                <a:t>0.160</a:t>
              </a:r>
              <a:endParaRPr lang="en-IL" sz="700">
                <a:solidFill>
                  <a:prstClr val="black"/>
                </a:solidFill>
              </a:endParaRP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4979D035-341F-4C3F-89ED-A7465CB101EB}"/>
                </a:ext>
              </a:extLst>
            </p:cNvPr>
            <p:cNvSpPr/>
            <p:nvPr/>
          </p:nvSpPr>
          <p:spPr>
            <a:xfrm>
              <a:off x="9218183" y="5071823"/>
              <a:ext cx="666694" cy="23760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IL" sz="700">
                  <a:solidFill>
                    <a:prstClr val="black"/>
                  </a:solidFill>
                </a:rPr>
                <a:t>0.</a:t>
              </a:r>
              <a:r>
                <a:rPr lang="en-US" sz="700">
                  <a:solidFill>
                    <a:prstClr val="black"/>
                  </a:solidFill>
                </a:rPr>
                <a:t>1</a:t>
              </a:r>
              <a:r>
                <a:rPr lang="en-IL" sz="700">
                  <a:solidFill>
                    <a:prstClr val="black"/>
                  </a:solidFill>
                </a:rPr>
                <a:t>4</a:t>
              </a:r>
              <a:r>
                <a:rPr lang="en-US" sz="700">
                  <a:solidFill>
                    <a:prstClr val="black"/>
                  </a:solidFill>
                </a:rPr>
                <a:t>5</a:t>
              </a:r>
              <a:endParaRPr lang="en-IL" sz="700">
                <a:solidFill>
                  <a:prstClr val="black"/>
                </a:solidFill>
              </a:endParaRP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B92D6D0E-1845-4E0D-B455-3EFBAA479EFF}"/>
                </a:ext>
              </a:extLst>
            </p:cNvPr>
            <p:cNvSpPr/>
            <p:nvPr/>
          </p:nvSpPr>
          <p:spPr>
            <a:xfrm>
              <a:off x="9607052" y="5047978"/>
              <a:ext cx="666694" cy="23760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IL" sz="700">
                  <a:solidFill>
                    <a:prstClr val="black"/>
                  </a:solidFill>
                </a:rPr>
                <a:t>0.</a:t>
              </a:r>
              <a:r>
                <a:rPr lang="en-US" sz="700">
                  <a:solidFill>
                    <a:prstClr val="black"/>
                  </a:solidFill>
                </a:rPr>
                <a:t>128</a:t>
              </a:r>
              <a:endParaRPr lang="en-IL" sz="700">
                <a:solidFill>
                  <a:prstClr val="black"/>
                </a:solidFill>
              </a:endParaRP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08DD97D2-DF79-4BA5-89E1-2A9F0930F82C}"/>
                </a:ext>
              </a:extLst>
            </p:cNvPr>
            <p:cNvSpPr/>
            <p:nvPr/>
          </p:nvSpPr>
          <p:spPr>
            <a:xfrm>
              <a:off x="10121417" y="5026404"/>
              <a:ext cx="666694" cy="23760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IL" sz="700">
                  <a:solidFill>
                    <a:prstClr val="black"/>
                  </a:solidFill>
                </a:rPr>
                <a:t>0.</a:t>
              </a:r>
              <a:r>
                <a:rPr lang="en-US" sz="700">
                  <a:solidFill>
                    <a:prstClr val="black"/>
                  </a:solidFill>
                </a:rPr>
                <a:t>111</a:t>
              </a:r>
              <a:endParaRPr lang="en-IL" sz="700">
                <a:solidFill>
                  <a:prstClr val="black"/>
                </a:solidFill>
              </a:endParaRP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FAD67715-2E9F-4EF3-A68F-241BC78D5870}"/>
                </a:ext>
              </a:extLst>
            </p:cNvPr>
            <p:cNvSpPr/>
            <p:nvPr/>
          </p:nvSpPr>
          <p:spPr>
            <a:xfrm>
              <a:off x="10722366" y="5166778"/>
              <a:ext cx="580111" cy="23760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IL" sz="700"/>
                <a:t>0.</a:t>
              </a:r>
              <a:r>
                <a:rPr lang="en-US" sz="700"/>
                <a:t>196</a:t>
              </a:r>
              <a:endParaRPr lang="en-IL" sz="700"/>
            </a:p>
          </p:txBody>
        </p: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86E3C88B-2BD1-4DCD-B84D-7FAB5138961F}"/>
              </a:ext>
            </a:extLst>
          </p:cNvPr>
          <p:cNvGrpSpPr/>
          <p:nvPr/>
        </p:nvGrpSpPr>
        <p:grpSpPr>
          <a:xfrm>
            <a:off x="3476603" y="420017"/>
            <a:ext cx="3318767" cy="2120839"/>
            <a:chOff x="6976408" y="7085066"/>
            <a:chExt cx="4664386" cy="2518875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BD044419-C820-43F8-A13D-5DF479B135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25" t="14138" r="22300" b="23065"/>
            <a:stretch/>
          </p:blipFill>
          <p:spPr>
            <a:xfrm>
              <a:off x="6976408" y="7460731"/>
              <a:ext cx="4664386" cy="2143210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226A10C-A066-44E0-BE30-8CEFBD7BB705}"/>
                </a:ext>
              </a:extLst>
            </p:cNvPr>
            <p:cNvSpPr txBox="1"/>
            <p:nvPr/>
          </p:nvSpPr>
          <p:spPr>
            <a:xfrm>
              <a:off x="9069862" y="7085066"/>
              <a:ext cx="892197" cy="4386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chemeClr val="accent2"/>
                  </a:solidFill>
                </a:rPr>
                <a:t>HL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68DCF678-45D0-4C84-B456-50C94C1AA249}"/>
                </a:ext>
              </a:extLst>
            </p:cNvPr>
            <p:cNvSpPr txBox="1"/>
            <p:nvPr/>
          </p:nvSpPr>
          <p:spPr>
            <a:xfrm>
              <a:off x="10413735" y="8699875"/>
              <a:ext cx="1129102" cy="3655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/>
                <a:t>Acid</a:t>
              </a:r>
            </a:p>
          </p:txBody>
        </p:sp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3343E0E6-9CD5-4FD7-A2DE-447F95E876C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540189" y="9037734"/>
              <a:ext cx="18952" cy="22914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EDC359EF-3E3C-45F2-8E4F-86EF7690FBAA}"/>
                </a:ext>
              </a:extLst>
            </p:cNvPr>
            <p:cNvSpPr/>
            <p:nvPr/>
          </p:nvSpPr>
          <p:spPr>
            <a:xfrm>
              <a:off x="7277723" y="7415614"/>
              <a:ext cx="895560" cy="42037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b="1" dirty="0"/>
                <a:t>NPQ</a:t>
              </a:r>
              <a:endParaRPr lang="en-US" sz="1000" dirty="0"/>
            </a:p>
            <a:p>
              <a:pPr algn="ctr"/>
              <a:r>
                <a:rPr lang="en-IL" sz="700" dirty="0"/>
                <a:t>0.1</a:t>
              </a:r>
              <a:r>
                <a:rPr lang="en-US" sz="700" dirty="0"/>
                <a:t>65</a:t>
              </a:r>
              <a:endParaRPr lang="en-IL" sz="700" dirty="0"/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52E5B005-5347-4B49-9990-EB78977ADCD2}"/>
                </a:ext>
              </a:extLst>
            </p:cNvPr>
            <p:cNvSpPr/>
            <p:nvPr/>
          </p:nvSpPr>
          <p:spPr>
            <a:xfrm>
              <a:off x="7611149" y="7950202"/>
              <a:ext cx="669411" cy="23760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IL" sz="700">
                  <a:solidFill>
                    <a:prstClr val="black"/>
                  </a:solidFill>
                </a:rPr>
                <a:t>0.</a:t>
              </a:r>
              <a:r>
                <a:rPr lang="en-US" sz="700">
                  <a:solidFill>
                    <a:prstClr val="black"/>
                  </a:solidFill>
                </a:rPr>
                <a:t>274</a:t>
              </a:r>
              <a:endParaRPr lang="en-IL" sz="700">
                <a:solidFill>
                  <a:prstClr val="black"/>
                </a:solidFill>
              </a:endParaRP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B978FEA7-3893-4AD3-8258-B5D0771CA078}"/>
                </a:ext>
              </a:extLst>
            </p:cNvPr>
            <p:cNvSpPr/>
            <p:nvPr/>
          </p:nvSpPr>
          <p:spPr>
            <a:xfrm>
              <a:off x="7805965" y="8021287"/>
              <a:ext cx="748274" cy="23760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IL" sz="700">
                  <a:solidFill>
                    <a:prstClr val="black"/>
                  </a:solidFill>
                </a:rPr>
                <a:t>0.</a:t>
              </a:r>
              <a:r>
                <a:rPr lang="en-US" sz="700">
                  <a:solidFill>
                    <a:prstClr val="black"/>
                  </a:solidFill>
                </a:rPr>
                <a:t>2</a:t>
              </a:r>
              <a:r>
                <a:rPr lang="en-IL" sz="700">
                  <a:solidFill>
                    <a:prstClr val="black"/>
                  </a:solidFill>
                </a:rPr>
                <a:t>8</a:t>
              </a:r>
              <a:r>
                <a:rPr lang="en-US" sz="700">
                  <a:solidFill>
                    <a:prstClr val="black"/>
                  </a:solidFill>
                </a:rPr>
                <a:t>6</a:t>
              </a:r>
              <a:endParaRPr lang="en-IL" sz="700">
                <a:solidFill>
                  <a:prstClr val="black"/>
                </a:solidFill>
              </a:endParaRP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002F7713-82C6-4724-AB9D-19B91D329DF6}"/>
                </a:ext>
              </a:extLst>
            </p:cNvPr>
            <p:cNvSpPr/>
            <p:nvPr/>
          </p:nvSpPr>
          <p:spPr>
            <a:xfrm>
              <a:off x="8543707" y="7664885"/>
              <a:ext cx="737442" cy="23760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IL" sz="700">
                  <a:solidFill>
                    <a:prstClr val="black"/>
                  </a:solidFill>
                </a:rPr>
                <a:t>0.</a:t>
              </a:r>
              <a:r>
                <a:rPr lang="en-US" sz="700">
                  <a:solidFill>
                    <a:prstClr val="black"/>
                  </a:solidFill>
                </a:rPr>
                <a:t>114</a:t>
              </a:r>
              <a:endParaRPr lang="en-IL" sz="700">
                <a:solidFill>
                  <a:prstClr val="black"/>
                </a:solidFill>
              </a:endParaRP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8EBA4522-84B0-4674-894F-677A4BF03433}"/>
                </a:ext>
              </a:extLst>
            </p:cNvPr>
            <p:cNvSpPr/>
            <p:nvPr/>
          </p:nvSpPr>
          <p:spPr>
            <a:xfrm>
              <a:off x="8861614" y="7594392"/>
              <a:ext cx="879749" cy="23760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IL" sz="700">
                  <a:solidFill>
                    <a:prstClr val="black"/>
                  </a:solidFill>
                </a:rPr>
                <a:t>0.0</a:t>
              </a:r>
              <a:r>
                <a:rPr lang="en-US" sz="700">
                  <a:solidFill>
                    <a:prstClr val="black"/>
                  </a:solidFill>
                </a:rPr>
                <a:t>96</a:t>
              </a:r>
              <a:endParaRPr lang="en-IL" sz="700">
                <a:solidFill>
                  <a:prstClr val="black"/>
                </a:solidFill>
              </a:endParaRPr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E51177C5-AAAD-4AFE-920C-5A29CE1FE9BB}"/>
                </a:ext>
              </a:extLst>
            </p:cNvPr>
            <p:cNvSpPr/>
            <p:nvPr/>
          </p:nvSpPr>
          <p:spPr>
            <a:xfrm>
              <a:off x="9241712" y="7523350"/>
              <a:ext cx="770289" cy="23760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IL" sz="700">
                  <a:solidFill>
                    <a:prstClr val="black"/>
                  </a:solidFill>
                </a:rPr>
                <a:t>0.0</a:t>
              </a:r>
              <a:r>
                <a:rPr lang="en-US" sz="700">
                  <a:solidFill>
                    <a:prstClr val="black"/>
                  </a:solidFill>
                </a:rPr>
                <a:t>67</a:t>
              </a:r>
              <a:endParaRPr lang="en-IL" sz="700">
                <a:solidFill>
                  <a:prstClr val="black"/>
                </a:solidFill>
              </a:endParaRP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848C90BB-A88C-4E1D-ABF7-A29470AEA3D6}"/>
                </a:ext>
              </a:extLst>
            </p:cNvPr>
            <p:cNvSpPr/>
            <p:nvPr/>
          </p:nvSpPr>
          <p:spPr>
            <a:xfrm>
              <a:off x="10160773" y="7403578"/>
              <a:ext cx="1183453" cy="23760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IL" sz="700">
                  <a:solidFill>
                    <a:prstClr val="black"/>
                  </a:solidFill>
                </a:rPr>
                <a:t>0.0</a:t>
              </a:r>
              <a:r>
                <a:rPr lang="en-US" sz="700">
                  <a:solidFill>
                    <a:prstClr val="black"/>
                  </a:solidFill>
                </a:rPr>
                <a:t>19</a:t>
              </a:r>
              <a:endParaRPr lang="en-IL" sz="700">
                <a:solidFill>
                  <a:prstClr val="black"/>
                </a:solidFill>
              </a:endParaRP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A7E36819-7464-4837-8CA2-E03F9158A97F}"/>
                </a:ext>
              </a:extLst>
            </p:cNvPr>
            <p:cNvSpPr/>
            <p:nvPr/>
          </p:nvSpPr>
          <p:spPr>
            <a:xfrm>
              <a:off x="10752500" y="7460732"/>
              <a:ext cx="632405" cy="23760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IL" sz="700">
                  <a:solidFill>
                    <a:prstClr val="black"/>
                  </a:solidFill>
                </a:rPr>
                <a:t>0.0</a:t>
              </a:r>
              <a:r>
                <a:rPr lang="en-US" sz="700">
                  <a:solidFill>
                    <a:prstClr val="black"/>
                  </a:solidFill>
                </a:rPr>
                <a:t>47</a:t>
              </a:r>
              <a:endParaRPr lang="en-IL" sz="700">
                <a:solidFill>
                  <a:prstClr val="black"/>
                </a:solidFill>
              </a:endParaRP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A0634C70-9E02-4098-B05E-8FB041F0E72A}"/>
                </a:ext>
              </a:extLst>
            </p:cNvPr>
            <p:cNvSpPr/>
            <p:nvPr/>
          </p:nvSpPr>
          <p:spPr>
            <a:xfrm>
              <a:off x="8080076" y="8095360"/>
              <a:ext cx="815847" cy="23760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IL" sz="700">
                  <a:solidFill>
                    <a:prstClr val="black"/>
                  </a:solidFill>
                </a:rPr>
                <a:t>0.</a:t>
              </a:r>
              <a:r>
                <a:rPr lang="en-US" sz="700">
                  <a:solidFill>
                    <a:prstClr val="black"/>
                  </a:solidFill>
                </a:rPr>
                <a:t>308</a:t>
              </a:r>
              <a:endParaRPr lang="en-IL" sz="700">
                <a:solidFill>
                  <a:prstClr val="black"/>
                </a:solidFill>
              </a:endParaRPr>
            </a:p>
          </p:txBody>
        </p:sp>
      </p:grpSp>
      <p:sp>
        <p:nvSpPr>
          <p:cNvPr id="49" name="Rectangle 48">
            <a:extLst>
              <a:ext uri="{FF2B5EF4-FFF2-40B4-BE49-F238E27FC236}">
                <a16:creationId xmlns:a16="http://schemas.microsoft.com/office/drawing/2014/main" id="{989E9A1D-2E11-486B-991C-AAFC237A5246}"/>
              </a:ext>
            </a:extLst>
          </p:cNvPr>
          <p:cNvSpPr/>
          <p:nvPr/>
        </p:nvSpPr>
        <p:spPr>
          <a:xfrm>
            <a:off x="4399335" y="1099442"/>
            <a:ext cx="939874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IL" sz="700">
                <a:solidFill>
                  <a:prstClr val="black"/>
                </a:solidFill>
              </a:rPr>
              <a:t>0.</a:t>
            </a:r>
            <a:r>
              <a:rPr lang="en-US" sz="700">
                <a:solidFill>
                  <a:prstClr val="black"/>
                </a:solidFill>
              </a:rPr>
              <a:t>217</a:t>
            </a:r>
            <a:endParaRPr lang="en-IL" sz="700">
              <a:solidFill>
                <a:prstClr val="black"/>
              </a:solidFill>
            </a:endParaRP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082BC434-96FA-4FEF-9CB0-CAD1690D43AC}"/>
              </a:ext>
            </a:extLst>
          </p:cNvPr>
          <p:cNvSpPr/>
          <p:nvPr/>
        </p:nvSpPr>
        <p:spPr>
          <a:xfrm>
            <a:off x="5371167" y="762835"/>
            <a:ext cx="842041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IL" sz="700">
                <a:solidFill>
                  <a:prstClr val="black"/>
                </a:solidFill>
              </a:rPr>
              <a:t>0.0</a:t>
            </a:r>
            <a:r>
              <a:rPr lang="en-US" sz="700">
                <a:solidFill>
                  <a:prstClr val="black"/>
                </a:solidFill>
              </a:rPr>
              <a:t>46</a:t>
            </a:r>
            <a:endParaRPr lang="en-IL" sz="700">
              <a:solidFill>
                <a:prstClr val="black"/>
              </a:solidFill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6F043CF-1C4B-46AC-8AE8-E31F48C5C034}"/>
              </a:ext>
            </a:extLst>
          </p:cNvPr>
          <p:cNvSpPr txBox="1"/>
          <p:nvPr/>
        </p:nvSpPr>
        <p:spPr>
          <a:xfrm>
            <a:off x="48414" y="1593624"/>
            <a:ext cx="6609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Light on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56F3B123-6362-4F72-9892-E404FD8A3FD2}"/>
              </a:ext>
            </a:extLst>
          </p:cNvPr>
          <p:cNvSpPr txBox="1"/>
          <p:nvPr/>
        </p:nvSpPr>
        <p:spPr>
          <a:xfrm>
            <a:off x="490234" y="1602139"/>
            <a:ext cx="6609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Light off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F15258E8-E07E-47E3-AE35-5CE8B54EA170}"/>
              </a:ext>
            </a:extLst>
          </p:cNvPr>
          <p:cNvCxnSpPr>
            <a:cxnSpLocks/>
            <a:stCxn id="44" idx="2"/>
          </p:cNvCxnSpPr>
          <p:nvPr/>
        </p:nvCxnSpPr>
        <p:spPr>
          <a:xfrm>
            <a:off x="820731" y="2063804"/>
            <a:ext cx="161912" cy="1680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03863160-2B4D-4542-B49E-615FAB238B06}"/>
              </a:ext>
            </a:extLst>
          </p:cNvPr>
          <p:cNvSpPr txBox="1"/>
          <p:nvPr/>
        </p:nvSpPr>
        <p:spPr>
          <a:xfrm>
            <a:off x="3950307" y="1620401"/>
            <a:ext cx="6609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Light off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BE9EDDFA-15C2-493C-9247-446FF2DF3419}"/>
              </a:ext>
            </a:extLst>
          </p:cNvPr>
          <p:cNvCxnSpPr>
            <a:cxnSpLocks/>
            <a:stCxn id="51" idx="2"/>
          </p:cNvCxnSpPr>
          <p:nvPr/>
        </p:nvCxnSpPr>
        <p:spPr>
          <a:xfrm>
            <a:off x="4280804" y="2082066"/>
            <a:ext cx="161912" cy="1680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4E5DAAD1-EB64-47A9-AE73-63E056CE3840}"/>
              </a:ext>
            </a:extLst>
          </p:cNvPr>
          <p:cNvSpPr txBox="1"/>
          <p:nvPr/>
        </p:nvSpPr>
        <p:spPr>
          <a:xfrm>
            <a:off x="3496158" y="1577975"/>
            <a:ext cx="6609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Light on</a:t>
            </a:r>
          </a:p>
        </p:txBody>
      </p: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E4B32AAE-635F-4590-A5F2-CD1DD0DF131B}"/>
              </a:ext>
            </a:extLst>
          </p:cNvPr>
          <p:cNvCxnSpPr>
            <a:cxnSpLocks/>
          </p:cNvCxnSpPr>
          <p:nvPr/>
        </p:nvCxnSpPr>
        <p:spPr>
          <a:xfrm>
            <a:off x="3845655" y="1997214"/>
            <a:ext cx="104652" cy="25984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41">
            <a:extLst>
              <a:ext uri="{FF2B5EF4-FFF2-40B4-BE49-F238E27FC236}">
                <a16:creationId xmlns:a16="http://schemas.microsoft.com/office/drawing/2014/main" id="{5D37DAEB-9531-4C3F-AB3B-0D625453EAAA}"/>
              </a:ext>
            </a:extLst>
          </p:cNvPr>
          <p:cNvSpPr txBox="1"/>
          <p:nvPr/>
        </p:nvSpPr>
        <p:spPr>
          <a:xfrm>
            <a:off x="509526" y="2683257"/>
            <a:ext cx="5734050" cy="21596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3</a:t>
            </a:r>
            <a:r>
              <a:rPr lang="en-US" sz="11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NPQ is not induced by high light or acidifying conditions in </a:t>
            </a:r>
            <a:r>
              <a:rPr lang="en-US" sz="1100" i="1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hlorella ohadii</a:t>
            </a:r>
            <a:r>
              <a:rPr lang="en-US" sz="11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grown under strict photoautotrophic conditions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1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luorescence traces of dark-adapted low and high light (LL, left, and HL, right)-grown cells. First under high light exposure (2000 </a:t>
            </a:r>
            <a:r>
              <a:rPr lang="el-GR" sz="11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μ</a:t>
            </a:r>
            <a:r>
              <a:rPr lang="en-US" sz="11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ol photons m</a:t>
            </a:r>
            <a:r>
              <a:rPr lang="en-US" sz="1100" kern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2</a:t>
            </a:r>
            <a:r>
              <a:rPr lang="en-US" sz="11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</a:t>
            </a:r>
            <a:r>
              <a:rPr lang="en-US" sz="1100" kern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1</a:t>
            </a:r>
            <a:r>
              <a:rPr lang="en-US" sz="11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, and then quenching was detected in response to the acidification of the media to pH 5.5 with acetic acid. Blue arrows indicate turning the light on/off. Black arrows indicate the point of acid addition. The numbers above each FM signal indicate the NPQ values which are very small compared to </a:t>
            </a:r>
            <a:r>
              <a:rPr lang="en-US" sz="1100" i="1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. reinhardtii </a:t>
            </a:r>
            <a:r>
              <a:rPr lang="en-US" sz="11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where they routinely attain 2.2-2.5 (see Fig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re</a:t>
            </a:r>
            <a:r>
              <a:rPr lang="en-US" sz="11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3)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graphs are representative of at least 3 biological repeats.</a:t>
            </a:r>
            <a:endParaRPr lang="en-IL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88423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3</TotalTime>
  <Words>197</Words>
  <Application>Microsoft Office PowerPoint</Application>
  <PresentationFormat>A4 Paper (210x297 mm)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di Schuster Lab</dc:creator>
  <cp:lastModifiedBy>Gadi Schuster Lab</cp:lastModifiedBy>
  <cp:revision>13</cp:revision>
  <dcterms:created xsi:type="dcterms:W3CDTF">2024-05-03T07:50:48Z</dcterms:created>
  <dcterms:modified xsi:type="dcterms:W3CDTF">2024-09-19T19:52:32Z</dcterms:modified>
</cp:coreProperties>
</file>